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>
        <p:scale>
          <a:sx n="195" d="100"/>
          <a:sy n="195" d="100"/>
        </p:scale>
        <p:origin x="11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59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75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37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90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460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629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074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057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406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64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09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46AEA-2A3C-DB40-9A86-7ADF8F3EA983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C8710-7956-6540-B69C-3E9DF9EB7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62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947E3A2-26B7-A643-840A-5884E89E97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1763" y="0"/>
            <a:ext cx="4354286" cy="1219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BB151FA-C19E-D34E-9E19-E3CF13DECA87}"/>
              </a:ext>
            </a:extLst>
          </p:cNvPr>
          <p:cNvSpPr txBox="1"/>
          <p:nvPr/>
        </p:nvSpPr>
        <p:spPr>
          <a:xfrm>
            <a:off x="0" y="842683"/>
            <a:ext cx="24384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S1 The identifications for the genes encoding marked by arrows: red 1-YdhC, </a:t>
            </a:r>
          </a:p>
          <a:p>
            <a:r>
              <a:rPr lang="en-US" dirty="0"/>
              <a:t>Purple 7-YdhB, orange 3-PurR</a:t>
            </a:r>
          </a:p>
        </p:txBody>
      </p:sp>
    </p:spTree>
    <p:extLst>
      <p:ext uri="{BB962C8B-B14F-4D97-AF65-F5344CB8AC3E}">
        <p14:creationId xmlns:p14="http://schemas.microsoft.com/office/powerpoint/2010/main" val="1455736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12</TotalTime>
  <Words>21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an D Rodionov</dc:creator>
  <cp:lastModifiedBy>Ivan D Rodionov</cp:lastModifiedBy>
  <cp:revision>3</cp:revision>
  <dcterms:created xsi:type="dcterms:W3CDTF">2020-04-09T20:37:16Z</dcterms:created>
  <dcterms:modified xsi:type="dcterms:W3CDTF">2020-04-17T15:29:35Z</dcterms:modified>
</cp:coreProperties>
</file>